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BAFC48-071F-41BB-9F43-9CA3C15FE5C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AA8A14-E762-4972-A9DF-D3142B1887E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E1AEC9-B93F-4E8C-AAAE-1AE5D43CE6A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E142A5-B363-44ED-92DA-FC874B983E7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3D6707-2402-4FD4-9579-56E5340BF8B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03CF8B-B08A-4317-B6AD-762EE2202A3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C0FC30-704B-4D9D-A038-0A13272D72F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93A4F6-690F-4B0D-A5BD-AC4F316AEA3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88A0E9-DA93-4B93-B61D-C3A5CFEF8A0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5B945B-21C9-4B7B-82AA-C4B0064B5E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548E54-20ED-4C14-A5D7-8C43539290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8F9370-141E-4D7F-8936-C52C8F4C57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049AF00-AE30-406C-AD4F-F36CB15B008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981080" y="1538280"/>
            <a:ext cx="1524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ay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1752480" y="1843200"/>
            <a:ext cx="1524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36 resident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2819520" y="2209680"/>
            <a:ext cx="533160" cy="8384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 flipH="1">
            <a:off x="1600200" y="2209680"/>
            <a:ext cx="533520" cy="8384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762120" y="3124080"/>
            <a:ext cx="1676160" cy="785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8 Resident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-3 p.m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2743200" y="3124080"/>
            <a:ext cx="1676520" cy="785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8 Resident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3-5p.m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 flipH="1">
            <a:off x="990360" y="3886200"/>
            <a:ext cx="228600" cy="3808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905120" y="3886200"/>
            <a:ext cx="228600" cy="3492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600200" y="4191120"/>
            <a:ext cx="1523880" cy="105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idactic Sess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40 minut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152280" y="4267080"/>
            <a:ext cx="1524240" cy="105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“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Hands-on” Sess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80 minut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6095880" y="1538280"/>
            <a:ext cx="1524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ay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5867280" y="1843200"/>
            <a:ext cx="1524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36 resident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6858000" y="2195640"/>
            <a:ext cx="533520" cy="8380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 flipH="1">
            <a:off x="5638680" y="2195640"/>
            <a:ext cx="533520" cy="8380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4800600" y="3110040"/>
            <a:ext cx="1676520" cy="785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8 Resident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-3 p.m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6781680" y="3110040"/>
            <a:ext cx="1676520" cy="785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8 Resident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3-5p.m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 flipH="1">
            <a:off x="3200040" y="1219320"/>
            <a:ext cx="609480" cy="304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5181480" y="1219320"/>
            <a:ext cx="685800" cy="304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2666880" y="363600"/>
            <a:ext cx="3810240" cy="785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ay 0 – Pre-test Complet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72 Resident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2819520" y="304920"/>
            <a:ext cx="3429000" cy="914400"/>
          </a:xfrm>
          <a:prstGeom prst="rect">
            <a:avLst/>
          </a:pr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5867280" y="1523880"/>
            <a:ext cx="1447920" cy="685800"/>
          </a:xfrm>
          <a:prstGeom prst="rect">
            <a:avLst/>
          </a:pr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1752480" y="1523880"/>
            <a:ext cx="1447920" cy="685800"/>
          </a:xfrm>
          <a:prstGeom prst="rect">
            <a:avLst/>
          </a:pr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1066680" y="3581280"/>
            <a:ext cx="990720" cy="304920"/>
          </a:xfrm>
          <a:prstGeom prst="rect">
            <a:avLst/>
          </a:pr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3048120" y="3581280"/>
            <a:ext cx="990360" cy="304920"/>
          </a:xfrm>
          <a:prstGeom prst="rect">
            <a:avLst/>
          </a:pr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5105520" y="3581280"/>
            <a:ext cx="990360" cy="304920"/>
          </a:xfrm>
          <a:prstGeom prst="rect">
            <a:avLst/>
          </a:pr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7086600" y="3581280"/>
            <a:ext cx="990720" cy="304920"/>
          </a:xfrm>
          <a:prstGeom prst="rect">
            <a:avLst/>
          </a:pr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"/>
          <p:cNvSpPr/>
          <p:nvPr/>
        </p:nvSpPr>
        <p:spPr>
          <a:xfrm>
            <a:off x="1066680" y="1538280"/>
            <a:ext cx="2438640" cy="785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idactic sess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40 minut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7391520" y="2362320"/>
            <a:ext cx="533160" cy="8380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 flipH="1">
            <a:off x="3124080" y="2057400"/>
            <a:ext cx="2438640" cy="15238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990720" y="3429000"/>
            <a:ext cx="2590560" cy="1894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IJ &amp; thyroi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live participants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0 minut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Immediately following didactic sess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 flipH="1">
            <a:off x="3200040" y="1219320"/>
            <a:ext cx="609480" cy="304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5181480" y="1219320"/>
            <a:ext cx="685800" cy="304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2666880" y="363600"/>
            <a:ext cx="3810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20 Minute Worksho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2819520" y="304920"/>
            <a:ext cx="3429000" cy="914400"/>
          </a:xfrm>
          <a:prstGeom prst="rect">
            <a:avLst/>
          </a:pr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1371600" y="1523880"/>
            <a:ext cx="1828800" cy="838440"/>
          </a:xfrm>
          <a:prstGeom prst="rect">
            <a:avLst/>
          </a:pr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5334120" y="1506600"/>
            <a:ext cx="2438280" cy="785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Hands-on sess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80 minut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5562720" y="1523880"/>
            <a:ext cx="1981080" cy="838440"/>
          </a:xfrm>
          <a:prstGeom prst="rect">
            <a:avLst/>
          </a:pr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6629400" y="2362320"/>
            <a:ext cx="0" cy="16002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6781680" y="3227400"/>
            <a:ext cx="2590920" cy="105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aracentesis (cadavers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0 minut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5257800" y="3898800"/>
            <a:ext cx="2590920" cy="105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horacentesis (cadavers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0 minut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2209680" y="2362320"/>
            <a:ext cx="0" cy="990360"/>
          </a:xfrm>
          <a:prstGeom prst="line">
            <a:avLst/>
          </a:prstGeom>
          <a:ln w="316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3276720" y="3276720"/>
            <a:ext cx="3200400" cy="147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ertioneal cavity &amp; Pleural/lun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cadavers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0 minut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 flipH="1">
            <a:off x="5333760" y="2362320"/>
            <a:ext cx="609480" cy="8380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8-09T20:38:20Z</dcterms:created>
  <dc:creator>m031000</dc:creator>
  <dc:description/>
  <dc:language>en-US</dc:language>
  <cp:lastModifiedBy>Mira T Keddis</cp:lastModifiedBy>
  <dcterms:modified xsi:type="dcterms:W3CDTF">2011-08-02T02:46:54Z</dcterms:modified>
  <cp:revision>6</cp:revision>
  <dc:subject/>
  <dc:title>Slide 1</dc:title>
</cp:coreProperties>
</file>